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74" r:id="rId2"/>
    <p:sldId id="276" r:id="rId3"/>
    <p:sldId id="275" r:id="rId4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912" autoAdjust="0"/>
    <p:restoredTop sz="91636" autoAdjust="0"/>
  </p:normalViewPr>
  <p:slideViewPr>
    <p:cSldViewPr snapToGrid="0">
      <p:cViewPr varScale="1">
        <p:scale>
          <a:sx n="74" d="100"/>
          <a:sy n="74" d="100"/>
        </p:scale>
        <p:origin x="3408" y="66"/>
      </p:cViewPr>
      <p:guideLst>
        <p:guide orient="horz" pos="3120"/>
        <p:guide pos="2160"/>
      </p:guideLst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EDRO MARÍA  FERNÁNDEZ SALGUERO" userId="aab7b8a6-e7f3-4c51-a019-33d22c8ca31a" providerId="ADAL" clId="{0DBA52AA-DD0E-A04C-9157-74D111E4CBF6}"/>
    <pc:docChg chg="modSld">
      <pc:chgData name="PEDRO MARÍA  FERNÁNDEZ SALGUERO" userId="aab7b8a6-e7f3-4c51-a019-33d22c8ca31a" providerId="ADAL" clId="{0DBA52AA-DD0E-A04C-9157-74D111E4CBF6}" dt="2021-10-19T15:20:49.105" v="6" actId="1076"/>
      <pc:docMkLst>
        <pc:docMk/>
      </pc:docMkLst>
      <pc:sldChg chg="modSp mod">
        <pc:chgData name="PEDRO MARÍA  FERNÁNDEZ SALGUERO" userId="aab7b8a6-e7f3-4c51-a019-33d22c8ca31a" providerId="ADAL" clId="{0DBA52AA-DD0E-A04C-9157-74D111E4CBF6}" dt="2021-10-19T15:20:49.105" v="6" actId="1076"/>
        <pc:sldMkLst>
          <pc:docMk/>
          <pc:sldMk cId="4111144893" sldId="256"/>
        </pc:sldMkLst>
        <pc:spChg chg="mod">
          <ac:chgData name="PEDRO MARÍA  FERNÁNDEZ SALGUERO" userId="aab7b8a6-e7f3-4c51-a019-33d22c8ca31a" providerId="ADAL" clId="{0DBA52AA-DD0E-A04C-9157-74D111E4CBF6}" dt="2021-10-19T15:20:28.988" v="3" actId="1076"/>
          <ac:spMkLst>
            <pc:docMk/>
            <pc:sldMk cId="4111144893" sldId="256"/>
            <ac:spMk id="21" creationId="{00000000-0000-0000-0000-000000000000}"/>
          </ac:spMkLst>
        </pc:spChg>
        <pc:spChg chg="mod">
          <ac:chgData name="PEDRO MARÍA  FERNÁNDEZ SALGUERO" userId="aab7b8a6-e7f3-4c51-a019-33d22c8ca31a" providerId="ADAL" clId="{0DBA52AA-DD0E-A04C-9157-74D111E4CBF6}" dt="2021-10-19T15:20:35.271" v="4" actId="1076"/>
          <ac:spMkLst>
            <pc:docMk/>
            <pc:sldMk cId="4111144893" sldId="256"/>
            <ac:spMk id="22" creationId="{00000000-0000-0000-0000-000000000000}"/>
          </ac:spMkLst>
        </pc:spChg>
        <pc:spChg chg="mod">
          <ac:chgData name="PEDRO MARÍA  FERNÁNDEZ SALGUERO" userId="aab7b8a6-e7f3-4c51-a019-33d22c8ca31a" providerId="ADAL" clId="{0DBA52AA-DD0E-A04C-9157-74D111E4CBF6}" dt="2021-10-19T15:20:49.105" v="6" actId="1076"/>
          <ac:spMkLst>
            <pc:docMk/>
            <pc:sldMk cId="4111144893" sldId="256"/>
            <ac:spMk id="23" creationId="{00000000-0000-0000-0000-000000000000}"/>
          </ac:spMkLst>
        </pc:spChg>
        <pc:spChg chg="mod">
          <ac:chgData name="PEDRO MARÍA  FERNÁNDEZ SALGUERO" userId="aab7b8a6-e7f3-4c51-a019-33d22c8ca31a" providerId="ADAL" clId="{0DBA52AA-DD0E-A04C-9157-74D111E4CBF6}" dt="2021-10-19T15:20:41.166" v="5" actId="1076"/>
          <ac:spMkLst>
            <pc:docMk/>
            <pc:sldMk cId="4111144893" sldId="256"/>
            <ac:spMk id="29" creationId="{00000000-0000-0000-0000-000000000000}"/>
          </ac:spMkLst>
        </pc:spChg>
        <pc:picChg chg="mod">
          <ac:chgData name="PEDRO MARÍA  FERNÁNDEZ SALGUERO" userId="aab7b8a6-e7f3-4c51-a019-33d22c8ca31a" providerId="ADAL" clId="{0DBA52AA-DD0E-A04C-9157-74D111E4CBF6}" dt="2021-10-19T15:20:41.166" v="5" actId="1076"/>
          <ac:picMkLst>
            <pc:docMk/>
            <pc:sldMk cId="4111144893" sldId="256"/>
            <ac:picMk id="2" creationId="{00000000-0000-0000-0000-000000000000}"/>
          </ac:picMkLst>
        </pc:picChg>
        <pc:picChg chg="mod">
          <ac:chgData name="PEDRO MARÍA  FERNÁNDEZ SALGUERO" userId="aab7b8a6-e7f3-4c51-a019-33d22c8ca31a" providerId="ADAL" clId="{0DBA52AA-DD0E-A04C-9157-74D111E4CBF6}" dt="2021-10-19T15:20:35.271" v="4" actId="1076"/>
          <ac:picMkLst>
            <pc:docMk/>
            <pc:sldMk cId="4111144893" sldId="256"/>
            <ac:picMk id="3" creationId="{00000000-0000-0000-0000-000000000000}"/>
          </ac:picMkLst>
        </pc:picChg>
        <pc:picChg chg="mod">
          <ac:chgData name="PEDRO MARÍA  FERNÁNDEZ SALGUERO" userId="aab7b8a6-e7f3-4c51-a019-33d22c8ca31a" providerId="ADAL" clId="{0DBA52AA-DD0E-A04C-9157-74D111E4CBF6}" dt="2021-10-19T15:20:49.105" v="6" actId="1076"/>
          <ac:picMkLst>
            <pc:docMk/>
            <pc:sldMk cId="4111144893" sldId="256"/>
            <ac:picMk id="25" creationId="{00000000-0000-0000-0000-000000000000}"/>
          </ac:picMkLst>
        </pc:picChg>
        <pc:picChg chg="mod">
          <ac:chgData name="PEDRO MARÍA  FERNÁNDEZ SALGUERO" userId="aab7b8a6-e7f3-4c51-a019-33d22c8ca31a" providerId="ADAL" clId="{0DBA52AA-DD0E-A04C-9157-74D111E4CBF6}" dt="2021-10-19T15:20:28.988" v="3" actId="1076"/>
          <ac:picMkLst>
            <pc:docMk/>
            <pc:sldMk cId="4111144893" sldId="256"/>
            <ac:picMk id="26" creationId="{00000000-0000-0000-0000-00000000000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B902E3-2AE6-4903-8ADD-8E00B8677FF9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C9D4B8-FEA3-418C-9B45-77455BF3A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1833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2097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91031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9499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52687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1084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6003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03306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82007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7650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1547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01367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73D239-F571-46D6-B9AC-B4820BE16060}" type="datetimeFigureOut">
              <a:rPr lang="es-ES" smtClean="0"/>
              <a:pPr/>
              <a:t>14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180BF3-5BA0-4038-BAAE-B0271FC2E0B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991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8451035"/>
              </p:ext>
            </p:extLst>
          </p:nvPr>
        </p:nvGraphicFramePr>
        <p:xfrm>
          <a:off x="641666" y="1849362"/>
          <a:ext cx="5574665" cy="5284089"/>
        </p:xfrm>
        <a:graphic>
          <a:graphicData uri="http://schemas.openxmlformats.org/drawingml/2006/table">
            <a:tbl>
              <a:tblPr firstRow="1" firstCol="1" bandRow="1"/>
              <a:tblGrid>
                <a:gridCol w="716915">
                  <a:extLst>
                    <a:ext uri="{9D8B030D-6E8A-4147-A177-3AD203B41FA5}">
                      <a16:colId xmlns:a16="http://schemas.microsoft.com/office/drawing/2014/main" val="3864528309"/>
                    </a:ext>
                  </a:extLst>
                </a:gridCol>
                <a:gridCol w="2340610">
                  <a:extLst>
                    <a:ext uri="{9D8B030D-6E8A-4147-A177-3AD203B41FA5}">
                      <a16:colId xmlns:a16="http://schemas.microsoft.com/office/drawing/2014/main" val="736650690"/>
                    </a:ext>
                  </a:extLst>
                </a:gridCol>
                <a:gridCol w="2517140">
                  <a:extLst>
                    <a:ext uri="{9D8B030D-6E8A-4147-A177-3AD203B41FA5}">
                      <a16:colId xmlns:a16="http://schemas.microsoft.com/office/drawing/2014/main" val="252894385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ward (5’ - 3’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verse (5’ - 3’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03457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hR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CCGGTGCAGAAAACAG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GCGGTCTAACTCTGTG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13007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xin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TGGGTCGCTTCTCTTGA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TCCCCACCTTGAATGAAG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86275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nd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AACTTCTCGGCAGTCA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GTGCGTGCAGAAGGAGAT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6096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D3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CAGCCAATGCCTTTG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GAGATTACTTTTTCAGTGCAGA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56747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-Jun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GAGTTGGCACCCACTGTT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CCCCTATCGACATGGAGT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46308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-My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CTGACGACGAGACCTTC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GGTAGGAGGCCAGCTTC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6117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yp1a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AGACAGCCTCATTGAGC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GCTCCACGAGATAGCAGT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40184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AE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ACTATGAACTATGGCGTGCA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GGGAGACTCGGAAAC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39793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apdh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GAAGCAGGCATCTGAGG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GAAGGTGGAAGAGTGGGA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67686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ck  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TGGCTGTGGATACTACAAGG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TCAGGCCACGGTCCATC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75080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l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TTGCCTTCTTGGGACTG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CCACGATTTCCCAGAGAA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42571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Klf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TTCTCGCCTGTGTGAGTT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AAGTCCCCTCTCTCCA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78180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ts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ACCCCAGCTAATGGACAA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TTTGCAGTCCAGGGACAT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72492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ts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TGTCCACAAGATGGGCTT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TCCATGCTGTCCTGTCTC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22233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ano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AGTACCTCAGCCTCCAGC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TGCTGAGCCCTTCTGAAT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25440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ct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CGAGTGGAAAGCAACTC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TCATGTCCTGGGACTCCT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94555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dk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2E2E2E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GGGGCACCCAAGTACAT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2E2E2E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GCCGGAGGAAAGTGAATGA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94929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PAR</a:t>
                      </a:r>
                      <a:r>
                        <a:rPr lang="en-GB" sz="1200" i="1">
                          <a:effectLst/>
                          <a:latin typeface="Symbol" panose="05050102010706020507" pitchFamily="18" charset="2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2E2E2E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TTCAGAAGAAGAACCGGAAC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2E2E2E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GCTTTTTCAGATCTTGGCATT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7314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PAR</a:t>
                      </a:r>
                      <a:r>
                        <a:rPr lang="en-GB" sz="1200" i="1">
                          <a:effectLst/>
                          <a:latin typeface="Symbol" panose="05050102010706020507" pitchFamily="18" charset="2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CCAATGGTTGCTGATTACAA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GGGAGTTAGAAGGTTCTTCATG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90478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XR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2E2E2E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GTTGCTGCGCATCCA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solidFill>
                            <a:srgbClr val="2E2E2E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GCTGCTAAATAACTCTTGCATGA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5415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lc2a2 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CAGAAGACAAGATCACCGG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CTGGTGTGACTGTAAGTGGG 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64837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lc2a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TGACCAAGCCCTGAATCT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GTAGGATGTGGTGATGAC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14331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ox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GCGAGCGCTGCACA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CATGAGCGTCTTGGTTTTC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77927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t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TCTGCACGTACTCCATTG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AAACCCTCAAGAGCCAA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13307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nf</a:t>
                      </a:r>
                      <a:r>
                        <a:rPr lang="es-ES" sz="1200" i="1">
                          <a:effectLst/>
                          <a:latin typeface="Symbol" panose="05050102010706020507" pitchFamily="18" charset="2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ACCACGCTCTTCTGTCT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TCCACTTGGTGGTTTGCT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09604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Yap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GAGAGACTGCGGTTGAA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AGGGATGCTGTAGCTGCTC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5817291"/>
                  </a:ext>
                </a:extLst>
              </a:tr>
            </a:tbl>
          </a:graphicData>
        </a:graphic>
      </p:graphicFrame>
      <p:sp>
        <p:nvSpPr>
          <p:cNvPr id="6" name="Rectángulo 5"/>
          <p:cNvSpPr/>
          <p:nvPr/>
        </p:nvSpPr>
        <p:spPr>
          <a:xfrm>
            <a:off x="1465774" y="727635"/>
            <a:ext cx="3926447" cy="590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</a:t>
            </a:r>
            <a:endParaRPr lang="es-ES" sz="12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igonucleotides sequences for gene expression analyses</a:t>
            </a:r>
            <a:endParaRPr lang="es-E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27989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7284612"/>
              </p:ext>
            </p:extLst>
          </p:nvPr>
        </p:nvGraphicFramePr>
        <p:xfrm>
          <a:off x="697186" y="1692172"/>
          <a:ext cx="5574665" cy="978535"/>
        </p:xfrm>
        <a:graphic>
          <a:graphicData uri="http://schemas.openxmlformats.org/drawingml/2006/table">
            <a:tbl>
              <a:tblPr firstRow="1" firstCol="1" bandRow="1"/>
              <a:tblGrid>
                <a:gridCol w="987425">
                  <a:extLst>
                    <a:ext uri="{9D8B030D-6E8A-4147-A177-3AD203B41FA5}">
                      <a16:colId xmlns:a16="http://schemas.microsoft.com/office/drawing/2014/main" val="3251248138"/>
                    </a:ext>
                  </a:extLst>
                </a:gridCol>
                <a:gridCol w="2430145">
                  <a:extLst>
                    <a:ext uri="{9D8B030D-6E8A-4147-A177-3AD203B41FA5}">
                      <a16:colId xmlns:a16="http://schemas.microsoft.com/office/drawing/2014/main" val="1372863251"/>
                    </a:ext>
                  </a:extLst>
                </a:gridCol>
                <a:gridCol w="2157095">
                  <a:extLst>
                    <a:ext uri="{9D8B030D-6E8A-4147-A177-3AD203B41FA5}">
                      <a16:colId xmlns:a16="http://schemas.microsoft.com/office/drawing/2014/main" val="155916859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ward (5’ - 3’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verse (5’ - 3’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45036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K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CTGCGCACACCAACA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GGAGTAGGAGCAGGAAGT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70446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CATCTCAAAGGTGACACG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AGTCTCTGCAGGTTCAC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6876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GCCTCTTATTCATGTGTGTGT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TTGAGCATGTCTTGATGG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23839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NF</a:t>
                      </a:r>
                      <a:r>
                        <a:rPr lang="en-GB" sz="1200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α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CAGACACTCACCTCATCCC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GGAACTGGCAGAAGAGGC </a:t>
                      </a:r>
                      <a:endParaRPr lang="es-ES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0281176"/>
                  </a:ext>
                </a:extLst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542322" y="2442107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sp>
        <p:nvSpPr>
          <p:cNvPr id="8" name="Rectángulo 7"/>
          <p:cNvSpPr/>
          <p:nvPr/>
        </p:nvSpPr>
        <p:spPr>
          <a:xfrm>
            <a:off x="1205843" y="679224"/>
            <a:ext cx="4557352" cy="590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2</a:t>
            </a:r>
            <a:endParaRPr lang="es-ES" sz="12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igonucleotide sequence used for Chromatin Immunoprecipitation</a:t>
            </a:r>
            <a:endParaRPr lang="es-E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1521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3786464"/>
              </p:ext>
            </p:extLst>
          </p:nvPr>
        </p:nvGraphicFramePr>
        <p:xfrm>
          <a:off x="641667" y="1285086"/>
          <a:ext cx="5574665" cy="3914140"/>
        </p:xfrm>
        <a:graphic>
          <a:graphicData uri="http://schemas.openxmlformats.org/drawingml/2006/table">
            <a:tbl>
              <a:tblPr firstRow="1" firstCol="1" bandRow="1"/>
              <a:tblGrid>
                <a:gridCol w="1347470">
                  <a:extLst>
                    <a:ext uri="{9D8B030D-6E8A-4147-A177-3AD203B41FA5}">
                      <a16:colId xmlns:a16="http://schemas.microsoft.com/office/drawing/2014/main" val="716733118"/>
                    </a:ext>
                  </a:extLst>
                </a:gridCol>
                <a:gridCol w="2430145">
                  <a:extLst>
                    <a:ext uri="{9D8B030D-6E8A-4147-A177-3AD203B41FA5}">
                      <a16:colId xmlns:a16="http://schemas.microsoft.com/office/drawing/2014/main" val="3552245009"/>
                    </a:ext>
                  </a:extLst>
                </a:gridCol>
                <a:gridCol w="1797050">
                  <a:extLst>
                    <a:ext uri="{9D8B030D-6E8A-4147-A177-3AD203B41FA5}">
                      <a16:colId xmlns:a16="http://schemas.microsoft.com/office/drawing/2014/main" val="426395971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tein Name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rand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centration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615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hR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nzo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03526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yclin D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Biotechnology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4786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2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Biotechnology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22497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5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32179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N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Biotechnology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78591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B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53858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1642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Fκβ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47952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ct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Biotechnology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76432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x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Biotechnology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55355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no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vus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5542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YAP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vus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71070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AP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vus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5900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Z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vus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63648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Symbol" panose="05050102010706020507" pitchFamily="18" charset="2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Catenin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39945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8165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istone H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gma-Aldrich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77726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K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63226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KT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9942397"/>
                  </a:ext>
                </a:extLst>
              </a:tr>
            </a:tbl>
          </a:graphicData>
        </a:graphic>
      </p:graphicFrame>
      <p:sp>
        <p:nvSpPr>
          <p:cNvPr id="6" name="Rectángulo 5"/>
          <p:cNvSpPr/>
          <p:nvPr/>
        </p:nvSpPr>
        <p:spPr>
          <a:xfrm>
            <a:off x="1714500" y="425056"/>
            <a:ext cx="3429000" cy="586956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3</a:t>
            </a:r>
            <a:endParaRPr lang="es-ES" sz="12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tibodies used in this study</a:t>
            </a:r>
            <a:endParaRPr lang="es-E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100192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44</TotalTime>
  <Words>228</Words>
  <Application>Microsoft Office PowerPoint</Application>
  <PresentationFormat>A4 (210 x 297 mm)</PresentationFormat>
  <Paragraphs>162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imes New Roman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udia</dc:creator>
  <cp:lastModifiedBy>Claudia</cp:lastModifiedBy>
  <cp:revision>167</cp:revision>
  <dcterms:created xsi:type="dcterms:W3CDTF">2021-01-18T18:07:39Z</dcterms:created>
  <dcterms:modified xsi:type="dcterms:W3CDTF">2022-05-14T13:55:11Z</dcterms:modified>
</cp:coreProperties>
</file>